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8" r:id="rId2"/>
    <p:sldId id="269" r:id="rId3"/>
    <p:sldId id="275" r:id="rId4"/>
    <p:sldId id="276" r:id="rId5"/>
    <p:sldId id="277" r:id="rId6"/>
    <p:sldId id="272" r:id="rId7"/>
    <p:sldId id="273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080"/>
    <a:srgbClr val="FFFFFF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136" d="100"/>
          <a:sy n="136" d="100"/>
        </p:scale>
        <p:origin x="1770" y="-35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782C-2922-4BFA-94BD-EB84582F7CF9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BD2F-D13F-4685-A650-80047EF7B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7502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782C-2922-4BFA-94BD-EB84582F7CF9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BD2F-D13F-4685-A650-80047EF7B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36039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782C-2922-4BFA-94BD-EB84582F7CF9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BD2F-D13F-4685-A650-80047EF7B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7481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782C-2922-4BFA-94BD-EB84582F7CF9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BD2F-D13F-4685-A650-80047EF7B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106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782C-2922-4BFA-94BD-EB84582F7CF9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BD2F-D13F-4685-A650-80047EF7B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72249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782C-2922-4BFA-94BD-EB84582F7CF9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BD2F-D13F-4685-A650-80047EF7B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97255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782C-2922-4BFA-94BD-EB84582F7CF9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BD2F-D13F-4685-A650-80047EF7B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3024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782C-2922-4BFA-94BD-EB84582F7CF9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BD2F-D13F-4685-A650-80047EF7B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92936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782C-2922-4BFA-94BD-EB84582F7CF9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BD2F-D13F-4685-A650-80047EF7B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66587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782C-2922-4BFA-94BD-EB84582F7CF9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BD2F-D13F-4685-A650-80047EF7B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80866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782C-2922-4BFA-94BD-EB84582F7CF9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BD2F-D13F-4685-A650-80047EF7B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7785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60782C-2922-4BFA-94BD-EB84582F7CF9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4ABD2F-D13F-4685-A650-80047EF7B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93444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openxmlformats.org/officeDocument/2006/relationships/image" Target="../media/image16.png"/><Relationship Id="rId18" Type="http://schemas.openxmlformats.org/officeDocument/2006/relationships/image" Target="../media/image21.png"/><Relationship Id="rId3" Type="http://schemas.microsoft.com/office/2007/relationships/hdphoto" Target="../media/hdphoto1.wdp"/><Relationship Id="rId7" Type="http://schemas.openxmlformats.org/officeDocument/2006/relationships/image" Target="../media/image10.png"/><Relationship Id="rId12" Type="http://schemas.openxmlformats.org/officeDocument/2006/relationships/image" Target="../media/image15.png"/><Relationship Id="rId17" Type="http://schemas.openxmlformats.org/officeDocument/2006/relationships/image" Target="../media/image20.png"/><Relationship Id="rId2" Type="http://schemas.openxmlformats.org/officeDocument/2006/relationships/image" Target="../media/image6.png"/><Relationship Id="rId16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5" Type="http://schemas.openxmlformats.org/officeDocument/2006/relationships/image" Target="../media/image8.png"/><Relationship Id="rId15" Type="http://schemas.openxmlformats.org/officeDocument/2006/relationships/image" Target="../media/image18.png"/><Relationship Id="rId10" Type="http://schemas.openxmlformats.org/officeDocument/2006/relationships/image" Target="../media/image13.png"/><Relationship Id="rId4" Type="http://schemas.openxmlformats.org/officeDocument/2006/relationships/image" Target="../media/image7.png"/><Relationship Id="rId9" Type="http://schemas.openxmlformats.org/officeDocument/2006/relationships/image" Target="../media/image12.png"/><Relationship Id="rId14" Type="http://schemas.openxmlformats.org/officeDocument/2006/relationships/image" Target="../media/image17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13" Type="http://schemas.openxmlformats.org/officeDocument/2006/relationships/image" Target="../media/image33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12" Type="http://schemas.openxmlformats.org/officeDocument/2006/relationships/image" Target="../media/image32.png"/><Relationship Id="rId17" Type="http://schemas.openxmlformats.org/officeDocument/2006/relationships/image" Target="../media/image37.png"/><Relationship Id="rId2" Type="http://schemas.openxmlformats.org/officeDocument/2006/relationships/image" Target="../media/image22.jpeg"/><Relationship Id="rId16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png"/><Relationship Id="rId11" Type="http://schemas.openxmlformats.org/officeDocument/2006/relationships/image" Target="../media/image31.png"/><Relationship Id="rId5" Type="http://schemas.openxmlformats.org/officeDocument/2006/relationships/image" Target="../media/image25.png"/><Relationship Id="rId15" Type="http://schemas.openxmlformats.org/officeDocument/2006/relationships/image" Target="../media/image35.png"/><Relationship Id="rId10" Type="http://schemas.openxmlformats.org/officeDocument/2006/relationships/image" Target="../media/image30.png"/><Relationship Id="rId4" Type="http://schemas.openxmlformats.org/officeDocument/2006/relationships/image" Target="../media/image24.png"/><Relationship Id="rId9" Type="http://schemas.openxmlformats.org/officeDocument/2006/relationships/image" Target="../media/image29.png"/><Relationship Id="rId14" Type="http://schemas.openxmlformats.org/officeDocument/2006/relationships/image" Target="../media/image3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2A82889-1A97-4D90-B02E-FD0D00157D85}"/>
              </a:ext>
            </a:extLst>
          </p:cNvPr>
          <p:cNvSpPr/>
          <p:nvPr/>
        </p:nvSpPr>
        <p:spPr>
          <a:xfrm>
            <a:off x="87682" y="12955"/>
            <a:ext cx="64383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197485" algn="just">
              <a:spcAft>
                <a:spcPts val="0"/>
              </a:spcAft>
              <a:tabLst>
                <a:tab pos="5514340" algn="l"/>
              </a:tabLst>
            </a:pPr>
            <a:r>
              <a:rPr lang="en-GB" sz="14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. S1. Representative examples of database-guided AML case analyses</a:t>
            </a:r>
            <a:endParaRPr lang="en-GB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94B05B1-0A2A-4171-A7BB-A8B765200300}"/>
              </a:ext>
            </a:extLst>
          </p:cNvPr>
          <p:cNvSpPr/>
          <p:nvPr/>
        </p:nvSpPr>
        <p:spPr>
          <a:xfrm>
            <a:off x="0" y="5524335"/>
            <a:ext cx="6858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e dots and the median values of the blasts belonging to the new AML case (red dots and circles) compared with the AML groups included in the databases: t(15;17) AML (blue), t(8;21) AML (green), </a:t>
            </a:r>
            <a:r>
              <a:rPr lang="en-GB" sz="9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nv</a:t>
            </a: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16)/t(16;16) AML (violet), and MLL-r AML (dark red). (A) Representative example of a typical case that clearly belongs to the t(15;17) AML group; the AML blast events fall within the 1-standard deviation (SD) curve for the t(15;17) AML group and outside of the 2-SD curves for the other AML groups, for all 3 tubes from the EF AML/MDS panel. (B) Representative example of an atypical case, for which the AML blasts fall inside the 1-SD curves for two AML groups, t(8;21) AML and </a:t>
            </a:r>
            <a:r>
              <a:rPr lang="en-GB" sz="9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nv</a:t>
            </a: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16)/t(16;16) AML, but the system score indicated that the best fit was for the </a:t>
            </a:r>
            <a:r>
              <a:rPr lang="en-GB" sz="9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nv</a:t>
            </a: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16)/t(16;16) AML group due to overlap in the 1-SD curves for all three tubes (Score of 3). The score obtained for the t(8;21) AML group was 2.5, and the score for the MLL-r AML group was 1.5. (C) Representative example of a case included in the other group; the AML blasts from the new case fall outside of the 2-SD curves for all AML groups for all three tubes.</a:t>
            </a:r>
            <a:endParaRPr lang="en-GB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9CE69BF7-5DF0-4C8D-8316-9FF77574A16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84195"/>
            <a:ext cx="6858000" cy="39079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44288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0DB17F1A-29E1-4338-8DDA-7B841445C925}"/>
              </a:ext>
            </a:extLst>
          </p:cNvPr>
          <p:cNvSpPr/>
          <p:nvPr/>
        </p:nvSpPr>
        <p:spPr>
          <a:xfrm>
            <a:off x="0" y="100208"/>
            <a:ext cx="6858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2. Compass database-guided </a:t>
            </a:r>
            <a:r>
              <a:rPr lang="en-GB" sz="1200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fN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alysis of a t(15;17) AML case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6DEEC370-A587-4ACB-96D8-D4943B4FD8CB}"/>
              </a:ext>
            </a:extLst>
          </p:cNvPr>
          <p:cNvSpPr/>
          <p:nvPr/>
        </p:nvSpPr>
        <p:spPr>
          <a:xfrm>
            <a:off x="105688" y="7597676"/>
            <a:ext cx="6396103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immunophenotypic data acquired at diagnosis and four follow-up time points for MRD in one t(15;17) AML case in cytological remission were compared with the results of quantitative reverse transcription–polymerase chain reaction (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RT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PCR). (A) Comparison between the Compass-guided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fN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MRD classification obtained using the eight-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lor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ulticolor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low cytometry (MFC) analysis and the MRD classification using routinely obtained molecular data. The blue circles and line correspond to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fN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MRD evaluation by flow cytometry, and the red circles and line correspond to the MRD based on molecular data. (B, C) Prospective comparison and classification of neutrophil- (yellow dots), monocyte- (green dots), and erythroid-committed CD45+lowCD117+ events (dark-red dots) and t(15;17) AML residual blasts (red dots and circle) from new, independent bone marrow samples corresponding to two different MRD follow-up points: (B) positive MRD, and (C) negative MRD [orange dots and circles represent the normal my-HPC areas; red dots representing AML residual blasts are clustered in the blue t(15;17) AML area]. Each individual circle represents the median fluorescence expression value for all immunophenotypic parameters of my-HPCs or AML blasts measured in the APS plots for individual samples; the contour lines in these plots represent the standard deviation (SD) curves (the dotted and continuous lines represent the 1-SD and 2-SD curves, respectively). Representative dot plots showing the immunophenotypes of normal my-HPCs (neutrophil-committed HPCs [yellow dots]; monocyte-committed HPCs [green dots]; erythroid-committed HPCs [dark-red dots]), and t(15;17) AML blasts (red dots). T-distributed stochastic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ighbor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mbedding (t-SNE) diagrams (TS) showing the clear discrimination between neutrophil-committed HPCs (yellow dots), monocyte-committed HPCs (green dots), erythroid-committed HPCs (dark-red dots), and t(15;17) AML blasts (red dots).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64D096C7-C4B0-40B6-A362-DBCF0DF862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593" y="377207"/>
            <a:ext cx="5394292" cy="72204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92501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B322844B-E12C-406B-BD09-F5F9C4695389}"/>
              </a:ext>
            </a:extLst>
          </p:cNvPr>
          <p:cNvSpPr/>
          <p:nvPr/>
        </p:nvSpPr>
        <p:spPr>
          <a:xfrm>
            <a:off x="4697" y="0"/>
            <a:ext cx="685330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3. Compass database-guided </a:t>
            </a:r>
            <a:r>
              <a:rPr lang="en-GB" sz="1200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fN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alysis in an MLL-r AML case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F9C81AB4-51E7-44BA-A7FD-593A1339DA8C}"/>
              </a:ext>
            </a:extLst>
          </p:cNvPr>
          <p:cNvSpPr/>
          <p:nvPr/>
        </p:nvSpPr>
        <p:spPr>
          <a:xfrm>
            <a:off x="-8675" y="7828766"/>
            <a:ext cx="6853302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GB" sz="9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immunophenotypic data acquired at diagnosis and five follow-up time points for MRD in one MLL-r AML case were compared with the results of quantitative reverse transcription–polymerase chain reaction (</a:t>
            </a:r>
            <a:r>
              <a:rPr lang="en-GB" sz="900" dirty="0" err="1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RT</a:t>
            </a:r>
            <a:r>
              <a:rPr lang="en-GB" sz="9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PCR). (A) Comparison between the </a:t>
            </a:r>
            <a:r>
              <a:rPr lang="en-GB" sz="900" dirty="0" err="1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fN</a:t>
            </a:r>
            <a:r>
              <a:rPr lang="en-GB" sz="9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MRD classification obtained by the eight-</a:t>
            </a:r>
            <a:r>
              <a:rPr lang="en-GB" sz="900" dirty="0" err="1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lor</a:t>
            </a:r>
            <a:r>
              <a:rPr lang="en-GB" sz="9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900" dirty="0" err="1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ulticolor</a:t>
            </a:r>
            <a:r>
              <a:rPr lang="en-GB" sz="9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low cytometry (MFC) analysis and the MRD classification using routinely obtained molecular data. The blue circles and line correspond to the </a:t>
            </a:r>
            <a:r>
              <a:rPr lang="en-GB" sz="900" dirty="0" err="1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fN</a:t>
            </a:r>
            <a:r>
              <a:rPr lang="en-GB" sz="9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MRD evaluation by flow cytometry, and the red circles and line correspond to the MRD based on molecular data. (B, C) Prospective comparison and classification of neutrophil- (yellow dots), monocyte-(green dots), and erythroid-committed CD45+low CD117+ events (dark red) and MLL-r AML blasts (red dots and circles) from new, independent bone marrow samples corresponding to two different MRD follow-up points. APS diagrams showing MLL-r AML residual cells (red dots and circles) clustered in the dark-red MLL-r AML areas. Each individual circle represents the median fluorescence expression value for all immunophenotypic parameters of the my-HPCs or MLL-r AML blasts measured in the APS plots for individual samples; the contour lines in these plots represent the standard deviation (SD) curves (dotted and continuous lines represent 1-SD and 2-SD, respectively). (B, C, left). Dot plots showing the immunophenotypes of neutrophil-committed HPCs (orange dots), monocyte-committed HPCs (green dots), erythroid-committed HPCs (dark-red dots), and AML blasts (red dots). (C, right). T-distributed stochastic </a:t>
            </a:r>
            <a:r>
              <a:rPr lang="en-GB" sz="900" dirty="0" err="1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ighbor</a:t>
            </a:r>
            <a:r>
              <a:rPr lang="en-GB" sz="9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mbedding (t-SNE) diagrams (TS) showing the clear discrimination between neutrophil-committed HPCs (yellow dots), monocyte-committed HPCs (green dots), erythroid-committed HPCs (dark-red dots), and MLL-r AML residual blasts (red dots).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EE5BE0D3-802A-4A8B-B2CD-FD5C53ABB96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4552" y="332322"/>
            <a:ext cx="5208895" cy="73513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04702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507B8C3-9640-4A44-B884-5405CBCE7380}"/>
              </a:ext>
            </a:extLst>
          </p:cNvPr>
          <p:cNvSpPr/>
          <p:nvPr/>
        </p:nvSpPr>
        <p:spPr>
          <a:xfrm>
            <a:off x="0" y="0"/>
            <a:ext cx="6858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4. Compass database-guided </a:t>
            </a:r>
            <a:r>
              <a:rPr lang="en-GB" sz="1200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fN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alysis in a t(8;21) AML case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E9223DA-2837-474A-B020-E04BAD8213D7}"/>
              </a:ext>
            </a:extLst>
          </p:cNvPr>
          <p:cNvSpPr/>
          <p:nvPr/>
        </p:nvSpPr>
        <p:spPr>
          <a:xfrm>
            <a:off x="0" y="7182177"/>
            <a:ext cx="6858000" cy="27238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immunophenotypic data acquired at diagnosis and eight follow-up time points for MRD in one t(8;21) AML case in cytological remission were compared with the results of quantitative reverse transcription–polymerase chain reaction (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RT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PCR). (A) Comparison between the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fN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MRD classification obtained by the eight-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lor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ulticolor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low cytometry (MFC) analysis and the MRD classification using routinely obtained molecular data. The blue circles and line correspond to the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fN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MRD evaluation by flow cytometry, and the red circles and line correspond to the MRD based on molecular data. (B, C) Prospective comparison and classification of neutrophil- (yellow dots), monocyte- (green dots), and erythroid-committed HPCs (dark-red dots) and residual t(8;21) AML blasts (red dots and circles) from two new, independent bone marrow samples: positive MFC-MRD (B) and negative MFC-MRD (C). (B, left) T-distributed stochastic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ighbor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mbedding (t-SNE) diagrams (TS) showing the clear discrimination between neutrophil-committed HPCs (yellow dots), monocyte-committed HPCs (green dots), erythroid-committed HPCs (dark-red dots), and t(8;21) AML blasts (red dots and circles). APS diagrams displaying the t(8;21) AML residual blasts (red dots and circles) clustered in the t(8;21) AML area (green circles and lines represent 1 standard deviation [SD] and 2 SDs for the t(8;21) AML group) and outside the normal my-HPC area (orange circles and lines represent 1 SD and 2 SDs for the normal my-HPC group). (B, right) Representative dot plots showing the immunophenotype of normal HPCs (neutrophil-committed HPCs [yellow dots], monocyte-committed HPCs [green dots], erythroid-committed HPCs [dark-red dots]) and t(8;21) AML blasts (red dots). (C, left) APS plots showing normal my-HPCs from the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yzed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(8;21) AML case (green dots and circles) clustered inside the normal my-HPC area (orange circles and lines represent 1 SD and 2 SDs for the normal my-HPC group) and outside of 2 SDs for the t(8;21) AML area of the database (green circles and lines representing 1 SD and 2 SDs, respectively). (C, right) Representative dot plots showing the immunophenotype of normal my-HPCs (green dots) inside of other singlets (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ray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ots). Each individual circle represents the median fluorescence expression value for all immunophenotypic parameters of the my-HPCs or t(8;21) AML blasts measured in APS plots for individual samples; the contour lines in these plots represent SD curves (the dotted and continuous lines represent 1-SD and 2-SD curves, respectively).</a:t>
            </a: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0D726BA1-C3B8-44B2-8CCA-CB5E8DCD93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898" y="188125"/>
            <a:ext cx="5018699" cy="70829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42953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A89E313F-092A-4BCF-A40D-032FA6D1CEF5}"/>
              </a:ext>
            </a:extLst>
          </p:cNvPr>
          <p:cNvSpPr/>
          <p:nvPr/>
        </p:nvSpPr>
        <p:spPr>
          <a:xfrm>
            <a:off x="-1" y="1"/>
            <a:ext cx="671395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5. Compass database-guided </a:t>
            </a:r>
            <a:r>
              <a:rPr lang="en-GB" sz="1200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fN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alysis in an </a:t>
            </a:r>
            <a:r>
              <a:rPr lang="en-GB" sz="1200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v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16) AML case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22A6BD69-E0F2-4280-B878-F9109337B79F}"/>
              </a:ext>
            </a:extLst>
          </p:cNvPr>
          <p:cNvSpPr/>
          <p:nvPr/>
        </p:nvSpPr>
        <p:spPr>
          <a:xfrm>
            <a:off x="0" y="7658891"/>
            <a:ext cx="6858000" cy="21698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immunophenotypic data acquired at diagnosis and six follow-up time points for MRD in one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v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16) AML case in cytological remission were compared with the result of quantitative reverse transcription–polymerase chain reaction (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RT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PCR). (A) Comparison between the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fN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MRD classification obtained by the eight-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lor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ulticolor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low cytometry (MFC) and the MRD classification using routinely obtained molecular data. The blue circles and line correspond to the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fN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MRD evaluation by flow cytometry, and the red circles and line correspond to the MRD based on molecular data. (B, C) Prospective comparison and classification of neutrophil- (yellow dots), monocyte- (green dots), and erythroid-committed HPCs (dark-red) from new, independent bone marrow samples corresponding to two different MRD follow-up points: (B) positive MRD; red dots inside 1 standard deviation (SD) of the purple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v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16) AML database area; (C) normal neutrophil-committed HPCs from AML case (yellow dots and circle) inside 1 SD of the normal neutrophil-committed HPC area from the database (orange circles and lines); normal monocyte-committed HPCs from the AML case (light green dots and circle) inside 1 SD of the normal monocyte-committed HPC area from the database (dark green circles and lines); normal erythroid-committed HPCs from the AML case (dark-red dots and largest circle) inside 1 SD of the normal erythroid-committed-HPC area from the database (dark-red circles and lines). Each individual circle represents the median fluorescence expression value for all immunophenotypic parameters of the my-HPCs or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v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16) AML blasts measured in APS plots for the individual samples included in the databases; the contour lines in these plots represent SD curves (the dotted and continuous lines represent 1-SD and 2-SD curves, respectively). (B, C right) Representative dot plots showing the immunophenotype of normal HPCs (neutrophil-committed HPCs [yellow dots], monocyte-committed HPCs [green dots], erythroid-committed HPCs [dark-red dots]) and AML blasts (red dots).</a:t>
            </a: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0DA3846E-E506-4FC7-BED3-A0E3DEB273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703" y="277000"/>
            <a:ext cx="5230535" cy="73818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72358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EF6FDF5-7F19-46C9-9B72-8E5644685C75}"/>
              </a:ext>
            </a:extLst>
          </p:cNvPr>
          <p:cNvSpPr/>
          <p:nvPr/>
        </p:nvSpPr>
        <p:spPr>
          <a:xfrm>
            <a:off x="307" y="20939"/>
            <a:ext cx="6858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6. Example of a false-positive MLL-r AML case identified by Compass database-guided analysis </a:t>
            </a:r>
            <a:r>
              <a:rPr lang="en-GB" sz="1200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arboring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he P</a:t>
            </a:r>
            <a:r>
              <a:rPr lang="en-GB" sz="1200" b="1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CALM-MLLT10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usion gene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EF8B3CED-F6D2-47B5-BB63-1E9F5F40B2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2024" y="592941"/>
            <a:ext cx="3947916" cy="3405105"/>
          </a:xfrm>
          <a:prstGeom prst="rect">
            <a:avLst/>
          </a:prstGeom>
        </p:spPr>
      </p:pic>
      <p:grpSp>
        <p:nvGrpSpPr>
          <p:cNvPr id="4" name="Groupe 3">
            <a:extLst>
              <a:ext uri="{FF2B5EF4-FFF2-40B4-BE49-F238E27FC236}">
                <a16:creationId xmlns:a16="http://schemas.microsoft.com/office/drawing/2014/main" id="{CB1AE6EB-CE5C-4D5B-BBC5-2B3F83A1838D}"/>
              </a:ext>
            </a:extLst>
          </p:cNvPr>
          <p:cNvGrpSpPr/>
          <p:nvPr/>
        </p:nvGrpSpPr>
        <p:grpSpPr>
          <a:xfrm>
            <a:off x="354842" y="3998046"/>
            <a:ext cx="5947019" cy="4323915"/>
            <a:chOff x="4625277" y="-18615"/>
            <a:chExt cx="7503467" cy="5845664"/>
          </a:xfrm>
        </p:grpSpPr>
        <p:pic>
          <p:nvPicPr>
            <p:cNvPr id="5" name="Image 4">
              <a:extLst>
                <a:ext uri="{FF2B5EF4-FFF2-40B4-BE49-F238E27FC236}">
                  <a16:creationId xmlns:a16="http://schemas.microsoft.com/office/drawing/2014/main" id="{9E96821E-1D68-4D90-B1EB-DF1D9821555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703372" y="286099"/>
              <a:ext cx="1629474" cy="1440000"/>
            </a:xfrm>
            <a:prstGeom prst="rect">
              <a:avLst/>
            </a:prstGeom>
          </p:spPr>
        </p:pic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47AB64CB-C7E7-429B-BA1F-0CD9DB16AEF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126732" y="286099"/>
              <a:ext cx="1629474" cy="1440000"/>
            </a:xfrm>
            <a:prstGeom prst="rect">
              <a:avLst/>
            </a:prstGeom>
          </p:spPr>
        </p:pic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CB390D98-278D-4FB3-8227-CCA663B8E06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550092" y="281427"/>
              <a:ext cx="1629474" cy="1440000"/>
            </a:xfrm>
            <a:prstGeom prst="rect">
              <a:avLst/>
            </a:prstGeom>
          </p:spPr>
        </p:pic>
        <p:pic>
          <p:nvPicPr>
            <p:cNvPr id="8" name="Image 7">
              <a:extLst>
                <a:ext uri="{FF2B5EF4-FFF2-40B4-BE49-F238E27FC236}">
                  <a16:creationId xmlns:a16="http://schemas.microsoft.com/office/drawing/2014/main" id="{86066719-B3C0-4276-9DAD-A67B9F53C49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0499270" y="281427"/>
              <a:ext cx="1629474" cy="1440000"/>
            </a:xfrm>
            <a:prstGeom prst="rect">
              <a:avLst/>
            </a:prstGeom>
          </p:spPr>
        </p:pic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F24127B0-97C8-42C6-A028-DB8CC3978F03}"/>
                </a:ext>
              </a:extLst>
            </p:cNvPr>
            <p:cNvSpPr txBox="1"/>
            <p:nvPr/>
          </p:nvSpPr>
          <p:spPr>
            <a:xfrm>
              <a:off x="4703372" y="-18615"/>
              <a:ext cx="3860718" cy="4993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A. Tube 1 EF AML/MDS panel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5628F07C-5437-409E-87B1-68B0801387F3}"/>
                </a:ext>
              </a:extLst>
            </p:cNvPr>
            <p:cNvSpPr txBox="1"/>
            <p:nvPr/>
          </p:nvSpPr>
          <p:spPr>
            <a:xfrm>
              <a:off x="4709130" y="1798672"/>
              <a:ext cx="3854960" cy="4993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B. Tube 2 EF AML/MDS panel</a:t>
              </a:r>
            </a:p>
          </p:txBody>
        </p:sp>
        <p:pic>
          <p:nvPicPr>
            <p:cNvPr id="11" name="Image 10">
              <a:extLst>
                <a:ext uri="{FF2B5EF4-FFF2-40B4-BE49-F238E27FC236}">
                  <a16:creationId xmlns:a16="http://schemas.microsoft.com/office/drawing/2014/main" id="{8D365F18-E249-403F-A48C-BBF8EA0BF66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625277" y="2240577"/>
              <a:ext cx="1643774" cy="1440000"/>
            </a:xfrm>
            <a:prstGeom prst="rect">
              <a:avLst/>
            </a:prstGeom>
          </p:spPr>
        </p:pic>
        <p:pic>
          <p:nvPicPr>
            <p:cNvPr id="12" name="Image 11">
              <a:extLst>
                <a:ext uri="{FF2B5EF4-FFF2-40B4-BE49-F238E27FC236}">
                  <a16:creationId xmlns:a16="http://schemas.microsoft.com/office/drawing/2014/main" id="{021A4762-B282-44D6-9F26-513D88D6568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028706" y="2244531"/>
              <a:ext cx="1643774" cy="1440000"/>
            </a:xfrm>
            <a:prstGeom prst="rect">
              <a:avLst/>
            </a:prstGeom>
          </p:spPr>
        </p:pic>
        <p:pic>
          <p:nvPicPr>
            <p:cNvPr id="13" name="Image 12">
              <a:extLst>
                <a:ext uri="{FF2B5EF4-FFF2-40B4-BE49-F238E27FC236}">
                  <a16:creationId xmlns:a16="http://schemas.microsoft.com/office/drawing/2014/main" id="{96059791-9CE3-4E8B-8C15-8701B42BE467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7535792" y="2248485"/>
              <a:ext cx="1643774" cy="1440000"/>
            </a:xfrm>
            <a:prstGeom prst="rect">
              <a:avLst/>
            </a:prstGeom>
          </p:spPr>
        </p:pic>
        <p:pic>
          <p:nvPicPr>
            <p:cNvPr id="14" name="Image 13">
              <a:extLst>
                <a:ext uri="{FF2B5EF4-FFF2-40B4-BE49-F238E27FC236}">
                  <a16:creationId xmlns:a16="http://schemas.microsoft.com/office/drawing/2014/main" id="{3AFBE285-A0B1-4700-9989-7BB6C0FC398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0446307" y="2248485"/>
              <a:ext cx="1643774" cy="1440000"/>
            </a:xfrm>
            <a:prstGeom prst="rect">
              <a:avLst/>
            </a:prstGeom>
          </p:spPr>
        </p:pic>
        <p:pic>
          <p:nvPicPr>
            <p:cNvPr id="15" name="Image 14">
              <a:extLst>
                <a:ext uri="{FF2B5EF4-FFF2-40B4-BE49-F238E27FC236}">
                  <a16:creationId xmlns:a16="http://schemas.microsoft.com/office/drawing/2014/main" id="{971A2605-F6AC-4768-A887-9F4554FCA7E4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696222" y="4374170"/>
              <a:ext cx="1643774" cy="1440000"/>
            </a:xfrm>
            <a:prstGeom prst="rect">
              <a:avLst/>
            </a:prstGeom>
          </p:spPr>
        </p:pic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270EFF49-8E46-47A6-B875-7D7C573B460D}"/>
                </a:ext>
              </a:extLst>
            </p:cNvPr>
            <p:cNvSpPr txBox="1"/>
            <p:nvPr/>
          </p:nvSpPr>
          <p:spPr>
            <a:xfrm>
              <a:off x="4709130" y="3821784"/>
              <a:ext cx="4377988" cy="4993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C. Tube 3 EF AML/MDS panel</a:t>
              </a:r>
            </a:p>
          </p:txBody>
        </p:sp>
        <p:pic>
          <p:nvPicPr>
            <p:cNvPr id="17" name="Image 16">
              <a:extLst>
                <a:ext uri="{FF2B5EF4-FFF2-40B4-BE49-F238E27FC236}">
                  <a16:creationId xmlns:a16="http://schemas.microsoft.com/office/drawing/2014/main" id="{438B0478-9EB7-4A82-9E62-98F9CD7DC541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6182387" y="4379490"/>
              <a:ext cx="1643774" cy="1440000"/>
            </a:xfrm>
            <a:prstGeom prst="rect">
              <a:avLst/>
            </a:prstGeom>
          </p:spPr>
        </p:pic>
        <p:pic>
          <p:nvPicPr>
            <p:cNvPr id="18" name="Image 17">
              <a:extLst>
                <a:ext uri="{FF2B5EF4-FFF2-40B4-BE49-F238E27FC236}">
                  <a16:creationId xmlns:a16="http://schemas.microsoft.com/office/drawing/2014/main" id="{11CC9882-ADFD-4B46-AA35-122A05336A28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7550092" y="4387049"/>
              <a:ext cx="1643774" cy="1440000"/>
            </a:xfrm>
            <a:prstGeom prst="rect">
              <a:avLst/>
            </a:prstGeom>
          </p:spPr>
        </p:pic>
        <p:pic>
          <p:nvPicPr>
            <p:cNvPr id="19" name="Image 18">
              <a:extLst>
                <a:ext uri="{FF2B5EF4-FFF2-40B4-BE49-F238E27FC236}">
                  <a16:creationId xmlns:a16="http://schemas.microsoft.com/office/drawing/2014/main" id="{8DEF5F70-2E70-4B88-83E0-8638D16189E5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8992039" y="4379490"/>
              <a:ext cx="1643774" cy="1440000"/>
            </a:xfrm>
            <a:prstGeom prst="rect">
              <a:avLst/>
            </a:prstGeom>
          </p:spPr>
        </p:pic>
        <p:pic>
          <p:nvPicPr>
            <p:cNvPr id="20" name="Image 19">
              <a:extLst>
                <a:ext uri="{FF2B5EF4-FFF2-40B4-BE49-F238E27FC236}">
                  <a16:creationId xmlns:a16="http://schemas.microsoft.com/office/drawing/2014/main" id="{0A925991-8CE7-4DA4-9905-07AB5D4A1720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10403961" y="4379426"/>
              <a:ext cx="1643774" cy="1440000"/>
            </a:xfrm>
            <a:prstGeom prst="rect">
              <a:avLst/>
            </a:prstGeom>
          </p:spPr>
        </p:pic>
        <p:pic>
          <p:nvPicPr>
            <p:cNvPr id="21" name="Image 20">
              <a:extLst>
                <a:ext uri="{FF2B5EF4-FFF2-40B4-BE49-F238E27FC236}">
                  <a16:creationId xmlns:a16="http://schemas.microsoft.com/office/drawing/2014/main" id="{BFF4BE91-DF3D-470E-ACAF-B88495223999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8855496" y="2256043"/>
              <a:ext cx="1643774" cy="1440000"/>
            </a:xfrm>
            <a:prstGeom prst="rect">
              <a:avLst/>
            </a:prstGeom>
          </p:spPr>
        </p:pic>
        <p:pic>
          <p:nvPicPr>
            <p:cNvPr id="22" name="Image 21">
              <a:extLst>
                <a:ext uri="{FF2B5EF4-FFF2-40B4-BE49-F238E27FC236}">
                  <a16:creationId xmlns:a16="http://schemas.microsoft.com/office/drawing/2014/main" id="{C87F6AF7-B724-48C7-812B-4C6B47E454C7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8869796" y="281427"/>
              <a:ext cx="1629474" cy="1440000"/>
            </a:xfrm>
            <a:prstGeom prst="rect">
              <a:avLst/>
            </a:prstGeom>
          </p:spPr>
        </p:pic>
      </p:grpSp>
      <p:sp>
        <p:nvSpPr>
          <p:cNvPr id="23" name="Rectangle 22">
            <a:extLst>
              <a:ext uri="{FF2B5EF4-FFF2-40B4-BE49-F238E27FC236}">
                <a16:creationId xmlns:a16="http://schemas.microsoft.com/office/drawing/2014/main" id="{0FD17DA5-0482-4C56-BA27-283CB3D20AAF}"/>
              </a:ext>
            </a:extLst>
          </p:cNvPr>
          <p:cNvSpPr/>
          <p:nvPr/>
        </p:nvSpPr>
        <p:spPr>
          <a:xfrm>
            <a:off x="0" y="8722900"/>
            <a:ext cx="6857999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rphological analysis of BM smears show that they are massively infiltrated by 63% medium-sized blasts, characterized as containing fine chromatin; nuclei with regular outlines and without nucleoli; sparse cytoplasm; moderately basophilic; and sometimes vacuolated. Rare granular blasts are also present. The leukemic cells (red dots) fall inside the 1-standard deviation (SD) curve of the MLL-r AML group (dark red), between the 1-SD and 2-SD curves of the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v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16)/t(16;16) AML group (violet) and the t(8;21) AML group (green), and outside of the 2-SD curve of the t(15;17) AML group (blue) and normal myeloid-committed HPC groups (orange). Cytogenetics showed 47,XX,+4,t(10;11)(p12;q21)[5]/48,idem,+9[12]/46,XX[3]. Following NGS testing, mutations in four different genes</a:t>
            </a:r>
            <a:r>
              <a:rPr lang="en-GB" sz="9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FLT3, PHF6, ASXL1, and WT1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were identified.</a:t>
            </a:r>
          </a:p>
        </p:txBody>
      </p:sp>
    </p:spTree>
    <p:extLst>
      <p:ext uri="{BB962C8B-B14F-4D97-AF65-F5344CB8AC3E}">
        <p14:creationId xmlns:p14="http://schemas.microsoft.com/office/powerpoint/2010/main" val="6044346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EFB84DC5-7E5A-419B-A77C-CC983515ABC4}"/>
              </a:ext>
            </a:extLst>
          </p:cNvPr>
          <p:cNvSpPr/>
          <p:nvPr/>
        </p:nvSpPr>
        <p:spPr>
          <a:xfrm>
            <a:off x="-23981" y="-31961"/>
            <a:ext cx="6858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7. Example of an </a:t>
            </a:r>
            <a:r>
              <a:rPr lang="en-GB" sz="1200" b="1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PM1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mutated AML with an APL‐like immunophenotype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0101AA62-7331-4132-9B04-EEA8DBF845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8439" y="299306"/>
            <a:ext cx="3226326" cy="3375397"/>
          </a:xfrm>
          <a:prstGeom prst="rect">
            <a:avLst/>
          </a:prstGeom>
        </p:spPr>
      </p:pic>
      <p:grpSp>
        <p:nvGrpSpPr>
          <p:cNvPr id="4" name="Groupe 3">
            <a:extLst>
              <a:ext uri="{FF2B5EF4-FFF2-40B4-BE49-F238E27FC236}">
                <a16:creationId xmlns:a16="http://schemas.microsoft.com/office/drawing/2014/main" id="{D674A7E9-CEC6-44AD-A48E-E3C616C89F36}"/>
              </a:ext>
            </a:extLst>
          </p:cNvPr>
          <p:cNvGrpSpPr/>
          <p:nvPr/>
        </p:nvGrpSpPr>
        <p:grpSpPr>
          <a:xfrm>
            <a:off x="94151" y="3683174"/>
            <a:ext cx="6669698" cy="4733492"/>
            <a:chOff x="4693627" y="-18615"/>
            <a:chExt cx="7518211" cy="5526507"/>
          </a:xfrm>
        </p:grpSpPr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B45500F2-0C35-4356-8A15-CC718D2D85DF}"/>
                </a:ext>
              </a:extLst>
            </p:cNvPr>
            <p:cNvSpPr txBox="1"/>
            <p:nvPr/>
          </p:nvSpPr>
          <p:spPr>
            <a:xfrm>
              <a:off x="4703372" y="-18615"/>
              <a:ext cx="33278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A. Tube 1 EF AML/MDS panel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A69D1102-1058-4B7F-88A2-D2A687845A6E}"/>
                </a:ext>
              </a:extLst>
            </p:cNvPr>
            <p:cNvSpPr txBox="1"/>
            <p:nvPr/>
          </p:nvSpPr>
          <p:spPr>
            <a:xfrm>
              <a:off x="4709130" y="1798672"/>
              <a:ext cx="33278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B. Tube 2 EF AML/MDS panel</a:t>
              </a: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E215BAF6-1A9F-4BCD-9EA7-0C14CC55680E}"/>
                </a:ext>
              </a:extLst>
            </p:cNvPr>
            <p:cNvSpPr txBox="1"/>
            <p:nvPr/>
          </p:nvSpPr>
          <p:spPr>
            <a:xfrm>
              <a:off x="4714887" y="3690491"/>
              <a:ext cx="33278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C. Tube 3 EF AML/MDS panel</a:t>
              </a:r>
            </a:p>
          </p:txBody>
        </p:sp>
        <p:pic>
          <p:nvPicPr>
            <p:cNvPr id="8" name="Image 7">
              <a:extLst>
                <a:ext uri="{FF2B5EF4-FFF2-40B4-BE49-F238E27FC236}">
                  <a16:creationId xmlns:a16="http://schemas.microsoft.com/office/drawing/2014/main" id="{72F32CE5-960D-45AF-B8B0-3B7FA512411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693627" y="359343"/>
              <a:ext cx="1643774" cy="1440000"/>
            </a:xfrm>
            <a:prstGeom prst="rect">
              <a:avLst/>
            </a:prstGeom>
          </p:spPr>
        </p:pic>
        <p:pic>
          <p:nvPicPr>
            <p:cNvPr id="9" name="Image 8">
              <a:extLst>
                <a:ext uri="{FF2B5EF4-FFF2-40B4-BE49-F238E27FC236}">
                  <a16:creationId xmlns:a16="http://schemas.microsoft.com/office/drawing/2014/main" id="{77B4DDF1-67D0-4674-8932-98B5E9E52A0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121878" y="358672"/>
              <a:ext cx="1643774" cy="1440000"/>
            </a:xfrm>
            <a:prstGeom prst="rect">
              <a:avLst/>
            </a:prstGeom>
          </p:spPr>
        </p:pic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212879B2-5FBC-40E9-9564-454CCE444AC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578121" y="358672"/>
              <a:ext cx="1643774" cy="1440000"/>
            </a:xfrm>
            <a:prstGeom prst="rect">
              <a:avLst/>
            </a:prstGeom>
          </p:spPr>
        </p:pic>
        <p:pic>
          <p:nvPicPr>
            <p:cNvPr id="11" name="Image 10">
              <a:extLst>
                <a:ext uri="{FF2B5EF4-FFF2-40B4-BE49-F238E27FC236}">
                  <a16:creationId xmlns:a16="http://schemas.microsoft.com/office/drawing/2014/main" id="{2161A40F-5D76-4844-829F-A954960B345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022878" y="358672"/>
              <a:ext cx="1643774" cy="1440000"/>
            </a:xfrm>
            <a:prstGeom prst="rect">
              <a:avLst/>
            </a:prstGeom>
          </p:spPr>
        </p:pic>
        <p:pic>
          <p:nvPicPr>
            <p:cNvPr id="12" name="Image 11">
              <a:extLst>
                <a:ext uri="{FF2B5EF4-FFF2-40B4-BE49-F238E27FC236}">
                  <a16:creationId xmlns:a16="http://schemas.microsoft.com/office/drawing/2014/main" id="{B393F4F4-7FCE-4D4D-8D2E-EF715752F30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0514379" y="358672"/>
              <a:ext cx="1643774" cy="1440000"/>
            </a:xfrm>
            <a:prstGeom prst="rect">
              <a:avLst/>
            </a:prstGeom>
          </p:spPr>
        </p:pic>
        <p:pic>
          <p:nvPicPr>
            <p:cNvPr id="13" name="Image 12">
              <a:extLst>
                <a:ext uri="{FF2B5EF4-FFF2-40B4-BE49-F238E27FC236}">
                  <a16:creationId xmlns:a16="http://schemas.microsoft.com/office/drawing/2014/main" id="{F5FA97BC-AC8A-4EE7-8455-9DD94AE0FA2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758048" y="2231416"/>
              <a:ext cx="1643774" cy="1440000"/>
            </a:xfrm>
            <a:prstGeom prst="rect">
              <a:avLst/>
            </a:prstGeom>
          </p:spPr>
        </p:pic>
        <p:pic>
          <p:nvPicPr>
            <p:cNvPr id="14" name="Image 13">
              <a:extLst>
                <a:ext uri="{FF2B5EF4-FFF2-40B4-BE49-F238E27FC236}">
                  <a16:creationId xmlns:a16="http://schemas.microsoft.com/office/drawing/2014/main" id="{2752EB6F-0B33-4CEA-83E0-488960448DF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190176" y="2231416"/>
              <a:ext cx="1643774" cy="1440000"/>
            </a:xfrm>
            <a:prstGeom prst="rect">
              <a:avLst/>
            </a:prstGeom>
          </p:spPr>
        </p:pic>
        <p:pic>
          <p:nvPicPr>
            <p:cNvPr id="15" name="Image 14">
              <a:extLst>
                <a:ext uri="{FF2B5EF4-FFF2-40B4-BE49-F238E27FC236}">
                  <a16:creationId xmlns:a16="http://schemas.microsoft.com/office/drawing/2014/main" id="{23C3E5E7-1D7A-499A-A363-FCF1327C96B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7642541" y="2231416"/>
              <a:ext cx="1643774" cy="1440000"/>
            </a:xfrm>
            <a:prstGeom prst="rect">
              <a:avLst/>
            </a:prstGeom>
          </p:spPr>
        </p:pic>
        <p:pic>
          <p:nvPicPr>
            <p:cNvPr id="16" name="Image 15">
              <a:extLst>
                <a:ext uri="{FF2B5EF4-FFF2-40B4-BE49-F238E27FC236}">
                  <a16:creationId xmlns:a16="http://schemas.microsoft.com/office/drawing/2014/main" id="{2BCAF74B-852F-49A9-8DFE-1D2D7C4083FC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8838022" y="2231416"/>
              <a:ext cx="1643774" cy="1440000"/>
            </a:xfrm>
            <a:prstGeom prst="rect">
              <a:avLst/>
            </a:prstGeom>
          </p:spPr>
        </p:pic>
        <p:pic>
          <p:nvPicPr>
            <p:cNvPr id="17" name="Image 16">
              <a:extLst>
                <a:ext uri="{FF2B5EF4-FFF2-40B4-BE49-F238E27FC236}">
                  <a16:creationId xmlns:a16="http://schemas.microsoft.com/office/drawing/2014/main" id="{1929AC62-EDCE-42AA-B01A-44129D93AAFC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0488170" y="2231416"/>
              <a:ext cx="1643774" cy="1440000"/>
            </a:xfrm>
            <a:prstGeom prst="rect">
              <a:avLst/>
            </a:prstGeom>
          </p:spPr>
        </p:pic>
        <p:pic>
          <p:nvPicPr>
            <p:cNvPr id="18" name="Image 17">
              <a:extLst>
                <a:ext uri="{FF2B5EF4-FFF2-40B4-BE49-F238E27FC236}">
                  <a16:creationId xmlns:a16="http://schemas.microsoft.com/office/drawing/2014/main" id="{D1310346-153A-4483-B1A1-CC86B1BFDEE0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747311" y="4067892"/>
              <a:ext cx="1643774" cy="1440000"/>
            </a:xfrm>
            <a:prstGeom prst="rect">
              <a:avLst/>
            </a:prstGeom>
          </p:spPr>
        </p:pic>
        <p:pic>
          <p:nvPicPr>
            <p:cNvPr id="19" name="Image 18">
              <a:extLst>
                <a:ext uri="{FF2B5EF4-FFF2-40B4-BE49-F238E27FC236}">
                  <a16:creationId xmlns:a16="http://schemas.microsoft.com/office/drawing/2014/main" id="{CAADD555-C74E-46E5-97A0-B971449F69C9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6175562" y="4067892"/>
              <a:ext cx="1643774" cy="1440000"/>
            </a:xfrm>
            <a:prstGeom prst="rect">
              <a:avLst/>
            </a:prstGeom>
          </p:spPr>
        </p:pic>
        <p:pic>
          <p:nvPicPr>
            <p:cNvPr id="20" name="Image 19">
              <a:extLst>
                <a:ext uri="{FF2B5EF4-FFF2-40B4-BE49-F238E27FC236}">
                  <a16:creationId xmlns:a16="http://schemas.microsoft.com/office/drawing/2014/main" id="{BF01101A-21D6-40DF-8640-0A118A2BC4CE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7603814" y="4067892"/>
              <a:ext cx="1643774" cy="1440000"/>
            </a:xfrm>
            <a:prstGeom prst="rect">
              <a:avLst/>
            </a:prstGeom>
          </p:spPr>
        </p:pic>
        <p:pic>
          <p:nvPicPr>
            <p:cNvPr id="21" name="Image 20">
              <a:extLst>
                <a:ext uri="{FF2B5EF4-FFF2-40B4-BE49-F238E27FC236}">
                  <a16:creationId xmlns:a16="http://schemas.microsoft.com/office/drawing/2014/main" id="{93961231-B29C-485F-A4FA-A66D76C8DF6E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9032063" y="4067892"/>
              <a:ext cx="1643774" cy="1440000"/>
            </a:xfrm>
            <a:prstGeom prst="rect">
              <a:avLst/>
            </a:prstGeom>
          </p:spPr>
        </p:pic>
        <p:pic>
          <p:nvPicPr>
            <p:cNvPr id="22" name="Image 21">
              <a:extLst>
                <a:ext uri="{FF2B5EF4-FFF2-40B4-BE49-F238E27FC236}">
                  <a16:creationId xmlns:a16="http://schemas.microsoft.com/office/drawing/2014/main" id="{69F2F723-2713-43DB-9C0F-953B4B5BB66A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10568064" y="4067892"/>
              <a:ext cx="1643774" cy="1440000"/>
            </a:xfrm>
            <a:prstGeom prst="rect">
              <a:avLst/>
            </a:prstGeom>
          </p:spPr>
        </p:pic>
      </p:grpSp>
      <p:sp>
        <p:nvSpPr>
          <p:cNvPr id="23" name="Rectangle 22">
            <a:extLst>
              <a:ext uri="{FF2B5EF4-FFF2-40B4-BE49-F238E27FC236}">
                <a16:creationId xmlns:a16="http://schemas.microsoft.com/office/drawing/2014/main" id="{13C1D24A-9F15-467E-BB38-B07634E75328}"/>
              </a:ext>
            </a:extLst>
          </p:cNvPr>
          <p:cNvSpPr/>
          <p:nvPr/>
        </p:nvSpPr>
        <p:spPr>
          <a:xfrm>
            <a:off x="10376" y="8821864"/>
            <a:ext cx="6858000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rphological analysis of the BM smears showed the presence of 84.5% blasts of variable sizes (medium to large), which appeared to be quite immature, characterized by a high nucleus to cytoplasmic ratio; fine chromatin; and sometimes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ucleolated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The cytoplasm is reduced and basophilic, with small visible granulations and without Auer rods. No bilobed forms were seen. The leukemic cells (red dots) fall within the 1-standard deviation (SD) curve of the t(15;17) AML group (dark blue) and outside of the 2-SD curve of the t(8;21) AML (green),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v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16)/t(16;16) AML (violet), and </a:t>
            </a:r>
            <a:r>
              <a:rPr lang="en-GB" sz="9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LL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r AML groups and the normal myeloid-committed HPC groups (orange).</a:t>
            </a:r>
          </a:p>
        </p:txBody>
      </p:sp>
    </p:spTree>
    <p:extLst>
      <p:ext uri="{BB962C8B-B14F-4D97-AF65-F5344CB8AC3E}">
        <p14:creationId xmlns:p14="http://schemas.microsoft.com/office/powerpoint/2010/main" val="273708764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595</TotalTime>
  <Words>2248</Words>
  <Application>Microsoft Office PowerPoint</Application>
  <PresentationFormat>Format A4 (210 x 297 mm)</PresentationFormat>
  <Paragraphs>20</Paragraphs>
  <Slides>7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rmen AANEI</dc:creator>
  <cp:lastModifiedBy>Carmen AANEI</cp:lastModifiedBy>
  <cp:revision>103</cp:revision>
  <dcterms:created xsi:type="dcterms:W3CDTF">2021-03-25T16:37:04Z</dcterms:created>
  <dcterms:modified xsi:type="dcterms:W3CDTF">2021-10-04T19:56:16Z</dcterms:modified>
</cp:coreProperties>
</file>